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7" r:id="rId2"/>
    <p:sldId id="270" r:id="rId3"/>
    <p:sldId id="268" r:id="rId4"/>
    <p:sldId id="271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BF84C37-FFE6-C320-DE50-ECC4716BE61F}" name="SANTANATOGLIA AGNESE" initials="SA" userId="S::agnese.santanatoglia@studenti.unicam.it::db3464af-6c5a-428c-9dd5-3b46c85fdb7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01EB4"/>
    <a:srgbClr val="3BCDEE"/>
    <a:srgbClr val="ED0003"/>
    <a:srgbClr val="EF8138"/>
    <a:srgbClr val="E71EDE"/>
    <a:srgbClr val="FAD907"/>
    <a:srgbClr val="3658D0"/>
    <a:srgbClr val="55BD66"/>
    <a:srgbClr val="37B14C"/>
    <a:srgbClr val="00FF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4843" autoAdjust="0"/>
    <p:restoredTop sz="96296"/>
  </p:normalViewPr>
  <p:slideViewPr>
    <p:cSldViewPr snapToGrid="0">
      <p:cViewPr>
        <p:scale>
          <a:sx n="125" d="100"/>
          <a:sy n="125" d="100"/>
        </p:scale>
        <p:origin x="90" y="-2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9384A3-9744-D847-A611-B8603E37D60C}" type="datetimeFigureOut">
              <a:rPr lang="it-IT" smtClean="0"/>
              <a:t>21/10/20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A4E4D5-B3D6-744B-B77E-27F9C028AE4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9340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15ADB-0FF6-4FA3-AFD0-A4156A454A7E}" type="datetimeFigureOut">
              <a:rPr lang="it-IT" smtClean="0"/>
              <a:t>21/10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B3FD3-CD6A-4E2E-AA12-1BC2956EA7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7766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15ADB-0FF6-4FA3-AFD0-A4156A454A7E}" type="datetimeFigureOut">
              <a:rPr lang="it-IT" smtClean="0"/>
              <a:t>21/10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B3FD3-CD6A-4E2E-AA12-1BC2956EA7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6636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15ADB-0FF6-4FA3-AFD0-A4156A454A7E}" type="datetimeFigureOut">
              <a:rPr lang="it-IT" smtClean="0"/>
              <a:t>21/10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B3FD3-CD6A-4E2E-AA12-1BC2956EA7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15026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15ADB-0FF6-4FA3-AFD0-A4156A454A7E}" type="datetimeFigureOut">
              <a:rPr lang="it-IT" smtClean="0"/>
              <a:t>21/10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B3FD3-CD6A-4E2E-AA12-1BC2956EA7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5602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15ADB-0FF6-4FA3-AFD0-A4156A454A7E}" type="datetimeFigureOut">
              <a:rPr lang="it-IT" smtClean="0"/>
              <a:t>21/10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B3FD3-CD6A-4E2E-AA12-1BC2956EA7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1502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15ADB-0FF6-4FA3-AFD0-A4156A454A7E}" type="datetimeFigureOut">
              <a:rPr lang="it-IT" smtClean="0"/>
              <a:t>21/10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B3FD3-CD6A-4E2E-AA12-1BC2956EA7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1910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15ADB-0FF6-4FA3-AFD0-A4156A454A7E}" type="datetimeFigureOut">
              <a:rPr lang="it-IT" smtClean="0"/>
              <a:t>21/10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B3FD3-CD6A-4E2E-AA12-1BC2956EA7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99029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15ADB-0FF6-4FA3-AFD0-A4156A454A7E}" type="datetimeFigureOut">
              <a:rPr lang="it-IT" smtClean="0"/>
              <a:t>21/10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B3FD3-CD6A-4E2E-AA12-1BC2956EA7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7764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15ADB-0FF6-4FA3-AFD0-A4156A454A7E}" type="datetimeFigureOut">
              <a:rPr lang="it-IT" smtClean="0"/>
              <a:t>21/10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B3FD3-CD6A-4E2E-AA12-1BC2956EA7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4022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15ADB-0FF6-4FA3-AFD0-A4156A454A7E}" type="datetimeFigureOut">
              <a:rPr lang="it-IT" smtClean="0"/>
              <a:t>21/10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B3FD3-CD6A-4E2E-AA12-1BC2956EA7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42631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15ADB-0FF6-4FA3-AFD0-A4156A454A7E}" type="datetimeFigureOut">
              <a:rPr lang="it-IT" smtClean="0"/>
              <a:t>21/10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B3FD3-CD6A-4E2E-AA12-1BC2956EA7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0625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C15ADB-0FF6-4FA3-AFD0-A4156A454A7E}" type="datetimeFigureOut">
              <a:rPr lang="it-IT" smtClean="0"/>
              <a:t>21/10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0B3FD3-CD6A-4E2E-AA12-1BC2956EA7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68438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96849804-FA23-025C-18F2-AC1EF04FACF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70" b="34547"/>
          <a:stretch/>
        </p:blipFill>
        <p:spPr>
          <a:xfrm>
            <a:off x="-6" y="1011382"/>
            <a:ext cx="12192000" cy="4003964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0031DFAF-7FBA-ECF9-6584-4159A84C9C60}"/>
              </a:ext>
            </a:extLst>
          </p:cNvPr>
          <p:cNvSpPr txBox="1"/>
          <p:nvPr/>
        </p:nvSpPr>
        <p:spPr>
          <a:xfrm>
            <a:off x="824753" y="6131859"/>
            <a:ext cx="10309412" cy="7261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F4B4E2FE-DBC5-772B-DCB4-760F4D3DC4C3}"/>
              </a:ext>
            </a:extLst>
          </p:cNvPr>
          <p:cNvSpPr txBox="1"/>
          <p:nvPr/>
        </p:nvSpPr>
        <p:spPr>
          <a:xfrm>
            <a:off x="872700" y="6119336"/>
            <a:ext cx="104465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A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contents of th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ed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tes, given for eight different filter coffee extraction methods with three different coffee beans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centration of acrylamide (ng/mL) for each coffee samples by HPLC-MS/MS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centration of chlorogenic acids (mg/L) for each coffee samples by HPLC-DAD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centration of caffeine (mg/L) for each coffee samples by HPLC-DAD.</a:t>
            </a:r>
          </a:p>
        </p:txBody>
      </p:sp>
    </p:spTree>
    <p:extLst>
      <p:ext uri="{BB962C8B-B14F-4D97-AF65-F5344CB8AC3E}">
        <p14:creationId xmlns:p14="http://schemas.microsoft.com/office/powerpoint/2010/main" val="4746125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/>
          <p:cNvSpPr txBox="1"/>
          <p:nvPr/>
        </p:nvSpPr>
        <p:spPr>
          <a:xfrm>
            <a:off x="357804" y="533349"/>
            <a:ext cx="6788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pic>
        <p:nvPicPr>
          <p:cNvPr id="13" name="Segnaposto contenuto 5">
            <a:extLst>
              <a:ext uri="{FF2B5EF4-FFF2-40B4-BE49-F238E27FC236}">
                <a16:creationId xmlns:a16="http://schemas.microsoft.com/office/drawing/2014/main" id="{2B17A11F-FA85-3D57-A112-692B2D52970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-702" t="84526" r="1" b="5363"/>
          <a:stretch/>
        </p:blipFill>
        <p:spPr>
          <a:xfrm>
            <a:off x="357804" y="4943624"/>
            <a:ext cx="11761376" cy="664234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1F1D8D13-8AB7-B349-2AC6-FCDAD7D8BA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" y="1250142"/>
            <a:ext cx="4004812" cy="3420000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1DA528E6-9B07-9DB9-7B11-411DD2B8FAF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00479" y="1250142"/>
            <a:ext cx="4168800" cy="3793608"/>
          </a:xfrm>
          <a:prstGeom prst="rect">
            <a:avLst/>
          </a:prstGeom>
        </p:spPr>
      </p:pic>
      <p:pic>
        <p:nvPicPr>
          <p:cNvPr id="11" name="Immagine 10">
            <a:extLst>
              <a:ext uri="{FF2B5EF4-FFF2-40B4-BE49-F238E27FC236}">
                <a16:creationId xmlns:a16="http://schemas.microsoft.com/office/drawing/2014/main" id="{6A491688-8BCE-1BFE-C7F3-E0797C51F6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28958" y="1250142"/>
            <a:ext cx="4240800" cy="3519864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374AC0AE-6998-D41A-BF3D-8C11965362C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515" r="68182" b="34141"/>
          <a:stretch/>
        </p:blipFill>
        <p:spPr>
          <a:xfrm>
            <a:off x="-1" y="3686468"/>
            <a:ext cx="3879273" cy="983674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C11C9C5F-7135-7F34-56BD-EC202973933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515" r="68182" b="34141"/>
          <a:stretch/>
        </p:blipFill>
        <p:spPr>
          <a:xfrm>
            <a:off x="4065414" y="3686468"/>
            <a:ext cx="3879273" cy="983674"/>
          </a:xfrm>
          <a:prstGeom prst="rect">
            <a:avLst/>
          </a:prstGeom>
        </p:spPr>
      </p:pic>
      <p:pic>
        <p:nvPicPr>
          <p:cNvPr id="12" name="Immagine 11">
            <a:extLst>
              <a:ext uri="{FF2B5EF4-FFF2-40B4-BE49-F238E27FC236}">
                <a16:creationId xmlns:a16="http://schemas.microsoft.com/office/drawing/2014/main" id="{C18201AD-A698-8B67-3750-7E322C4E6BD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515" r="68182" b="34141"/>
          <a:stretch/>
        </p:blipFill>
        <p:spPr>
          <a:xfrm>
            <a:off x="8005290" y="3686468"/>
            <a:ext cx="3879273" cy="983674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CEE4C0B7-78D7-095D-DF57-5246872CC449}"/>
              </a:ext>
            </a:extLst>
          </p:cNvPr>
          <p:cNvSpPr txBox="1"/>
          <p:nvPr/>
        </p:nvSpPr>
        <p:spPr>
          <a:xfrm>
            <a:off x="872700" y="6119336"/>
            <a:ext cx="104465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B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contents of th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ed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tes, given for eight different filter coffee extraction methods with three different coffee beans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centration of acrylamide (ng/mL) for each coffee samples by HPLC-MS/MS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centration of chlorogenic acids (mg/L) for each coffee samples by HPLC-DAD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centration of caffeine (mg/L) for each coffee samples by HPLC-DAD.</a:t>
            </a:r>
          </a:p>
        </p:txBody>
      </p:sp>
    </p:spTree>
    <p:extLst>
      <p:ext uri="{BB962C8B-B14F-4D97-AF65-F5344CB8AC3E}">
        <p14:creationId xmlns:p14="http://schemas.microsoft.com/office/powerpoint/2010/main" val="40359037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/>
          <p:cNvSpPr txBox="1"/>
          <p:nvPr/>
        </p:nvSpPr>
        <p:spPr>
          <a:xfrm>
            <a:off x="357804" y="533349"/>
            <a:ext cx="6788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pic>
        <p:nvPicPr>
          <p:cNvPr id="10" name="Immagine 9"/>
          <p:cNvPicPr>
            <a:picLocks noChangeAspect="1"/>
          </p:cNvPicPr>
          <p:nvPr/>
        </p:nvPicPr>
        <p:blipFill rotWithShape="1">
          <a:blip r:embed="rId2"/>
          <a:srcRect l="57170" t="1635" r="18632" b="78491"/>
          <a:stretch/>
        </p:blipFill>
        <p:spPr>
          <a:xfrm>
            <a:off x="4985577" y="5091110"/>
            <a:ext cx="2220835" cy="1026000"/>
          </a:xfrm>
          <a:prstGeom prst="rect">
            <a:avLst/>
          </a:prstGeom>
        </p:spPr>
      </p:pic>
      <p:pic>
        <p:nvPicPr>
          <p:cNvPr id="13" name="Segnaposto contenuto 5">
            <a:extLst>
              <a:ext uri="{FF2B5EF4-FFF2-40B4-BE49-F238E27FC236}">
                <a16:creationId xmlns:a16="http://schemas.microsoft.com/office/drawing/2014/main" id="{2B17A11F-FA85-3D57-A112-692B2D52970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-702" t="84526" r="1" b="5363"/>
          <a:stretch/>
        </p:blipFill>
        <p:spPr>
          <a:xfrm>
            <a:off x="430624" y="4474139"/>
            <a:ext cx="11761376" cy="664234"/>
          </a:xfrm>
          <a:prstGeom prst="rect">
            <a:avLst/>
          </a:prstGeom>
        </p:spPr>
      </p:pic>
      <p:pic>
        <p:nvPicPr>
          <p:cNvPr id="2" name="Immagine 1">
            <a:extLst>
              <a:ext uri="{FF2B5EF4-FFF2-40B4-BE49-F238E27FC236}">
                <a16:creationId xmlns:a16="http://schemas.microsoft.com/office/drawing/2014/main" id="{7CCE8F66-869D-D583-E84D-E8115BDF0E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479" y="1058795"/>
            <a:ext cx="3810000" cy="3429000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0C98B91D-D2C2-B027-593B-BFA2361B22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90994" y="1056569"/>
            <a:ext cx="3810000" cy="3429000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B76EB166-E517-8EDA-01ED-4D586A5AEAD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91485" y="1056569"/>
            <a:ext cx="3810000" cy="3429000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25681583-0CFA-7F1A-20CE-94933D4508E0}"/>
              </a:ext>
            </a:extLst>
          </p:cNvPr>
          <p:cNvSpPr txBox="1"/>
          <p:nvPr/>
        </p:nvSpPr>
        <p:spPr>
          <a:xfrm>
            <a:off x="872700" y="6119336"/>
            <a:ext cx="104465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C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contents of th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ed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tes, given for eight different filter coffee extraction methods with three different coffee beans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centration of acrylamide (ng/mL) for each coffee samples by HPLC-MS/MS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centration of chlorogenic acids (mg/L) for each coffee samples by HPLC-DAD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centration of caffeine (mg/L) for each coffee samples by HPLC-DAD.</a:t>
            </a:r>
          </a:p>
        </p:txBody>
      </p:sp>
    </p:spTree>
    <p:extLst>
      <p:ext uri="{BB962C8B-B14F-4D97-AF65-F5344CB8AC3E}">
        <p14:creationId xmlns:p14="http://schemas.microsoft.com/office/powerpoint/2010/main" val="3351109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193EA305-8C54-3BD9-949F-C7C46AE5571F}"/>
              </a:ext>
            </a:extLst>
          </p:cNvPr>
          <p:cNvSpPr txBox="1"/>
          <p:nvPr/>
        </p:nvSpPr>
        <p:spPr>
          <a:xfrm>
            <a:off x="1083425" y="332510"/>
            <a:ext cx="100251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article size results (mean ± standard deviation) obtained with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stersizer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3000 Aero Series (Malvern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Nalytical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td., UK). </a:t>
            </a:r>
            <a:endParaRPr lang="it-I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FA3C7230-03F6-816F-A6C9-EAF9FD4EBF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5295138"/>
              </p:ext>
            </p:extLst>
          </p:nvPr>
        </p:nvGraphicFramePr>
        <p:xfrm>
          <a:off x="1083424" y="1767840"/>
          <a:ext cx="10025149" cy="1661160"/>
        </p:xfrm>
        <a:graphic>
          <a:graphicData uri="http://schemas.openxmlformats.org/drawingml/2006/table">
            <a:tbl>
              <a:tblPr firstRow="1" firstCol="1" bandRow="1"/>
              <a:tblGrid>
                <a:gridCol w="1796866">
                  <a:extLst>
                    <a:ext uri="{9D8B030D-6E8A-4147-A177-3AD203B41FA5}">
                      <a16:colId xmlns:a16="http://schemas.microsoft.com/office/drawing/2014/main" val="4174746200"/>
                    </a:ext>
                  </a:extLst>
                </a:gridCol>
                <a:gridCol w="1498057">
                  <a:extLst>
                    <a:ext uri="{9D8B030D-6E8A-4147-A177-3AD203B41FA5}">
                      <a16:colId xmlns:a16="http://schemas.microsoft.com/office/drawing/2014/main" val="1639921898"/>
                    </a:ext>
                  </a:extLst>
                </a:gridCol>
                <a:gridCol w="1997409">
                  <a:extLst>
                    <a:ext uri="{9D8B030D-6E8A-4147-A177-3AD203B41FA5}">
                      <a16:colId xmlns:a16="http://schemas.microsoft.com/office/drawing/2014/main" val="329576826"/>
                    </a:ext>
                  </a:extLst>
                </a:gridCol>
                <a:gridCol w="1498057">
                  <a:extLst>
                    <a:ext uri="{9D8B030D-6E8A-4147-A177-3AD203B41FA5}">
                      <a16:colId xmlns:a16="http://schemas.microsoft.com/office/drawing/2014/main" val="3712898423"/>
                    </a:ext>
                  </a:extLst>
                </a:gridCol>
                <a:gridCol w="1736703">
                  <a:extLst>
                    <a:ext uri="{9D8B030D-6E8A-4147-A177-3AD203B41FA5}">
                      <a16:colId xmlns:a16="http://schemas.microsoft.com/office/drawing/2014/main" val="2166040257"/>
                    </a:ext>
                  </a:extLst>
                </a:gridCol>
                <a:gridCol w="1498057">
                  <a:extLst>
                    <a:ext uri="{9D8B030D-6E8A-4147-A177-3AD203B41FA5}">
                      <a16:colId xmlns:a16="http://schemas.microsoft.com/office/drawing/2014/main" val="4222072962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mple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b="1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rticle</a:t>
                      </a:r>
                      <a:r>
                        <a:rPr lang="it-IT" sz="9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size (</a:t>
                      </a:r>
                      <a:r>
                        <a:rPr lang="it-IT" sz="900" b="1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μm</a:t>
                      </a:r>
                      <a:r>
                        <a:rPr lang="it-IT" sz="9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mple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b="1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rticle</a:t>
                      </a:r>
                      <a:r>
                        <a:rPr lang="it-IT" sz="9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size (</a:t>
                      </a:r>
                      <a:r>
                        <a:rPr lang="it-IT" sz="900" b="1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μm</a:t>
                      </a:r>
                      <a:r>
                        <a:rPr lang="it-IT" sz="9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mple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b="1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rticle</a:t>
                      </a:r>
                      <a:r>
                        <a:rPr lang="it-IT" sz="9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size (</a:t>
                      </a:r>
                      <a:r>
                        <a:rPr lang="it-IT" sz="900" b="1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μm</a:t>
                      </a:r>
                      <a:r>
                        <a:rPr lang="it-IT" sz="9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094257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EROPRESS LIGHT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30.32 ± 4.50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EROPRESS MEDIUM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72.65 ± 5.25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EROPRESS DARK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40.47 ± 9.36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7140783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EMEX LIGHT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40.78 ± 3.72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EMEX MEDIUM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0.19 ± 6.07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EMEX DARK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94.53 ± 4.25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1298604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LEVER LIGHT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76.44 ± 1.92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LEVER MEDIUM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78.31 ± 2.44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LEVER DARK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24.79 ± 4.44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4627190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RENCH PRESS LIGHT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46.35 ± 2.41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RENCH PRESS MEDIUM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31.58 ± 4.11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RENCH PRESS DARK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20.47 ± 1.25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50166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KA LIGHT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29.23 ± 4.95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KA MEDIUM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55.58 ± 1.3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KA DARK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84.41 ± 2.17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5995784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URE BREW LIGHT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50.33 ± 7.08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URE BREW MEDIUM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30.79 ± 8.69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URE BREW DARK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40.72 ± 5.68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3959121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URKISH LIGHT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1.18 ± 1.22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URKISH MEDIUM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9.31 ± 1.74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URKISH DARK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2.18 ± 0.98</a:t>
                      </a:r>
                      <a:endParaRPr lang="it-IT" sz="12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280787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60 LIGHT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40.38 ± 7.51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60 MEDIUM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60 ± 5.94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60 DARK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40.07 ± 6.55</a:t>
                      </a:r>
                      <a:endParaRPr lang="it-IT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4423492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16137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14</Words>
  <Application>Microsoft Office PowerPoint</Application>
  <PresentationFormat>Widescreen</PresentationFormat>
  <Paragraphs>6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ema di 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MDPI</cp:lastModifiedBy>
  <cp:revision>74</cp:revision>
  <dcterms:created xsi:type="dcterms:W3CDTF">2023-05-02T07:07:52Z</dcterms:created>
  <dcterms:modified xsi:type="dcterms:W3CDTF">2023-10-21T04:30:33Z</dcterms:modified>
</cp:coreProperties>
</file>